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5" d="100"/>
          <a:sy n="75" d="100"/>
        </p:scale>
        <p:origin x="-1352" y="-4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interSettings" Target="printerSettings/printerSettings1.bin"/><Relationship Id="rId21" Type="http://schemas.openxmlformats.org/officeDocument/2006/relationships/presProps" Target="presProps.xml"/><Relationship Id="rId22" Type="http://schemas.openxmlformats.org/officeDocument/2006/relationships/viewProps" Target="viewProps.xml"/><Relationship Id="rId23" Type="http://schemas.openxmlformats.org/officeDocument/2006/relationships/theme" Target="theme/theme1.xml"/><Relationship Id="rId2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29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639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086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433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015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0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926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892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824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194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387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72545-602E-794A-9715-BDB3302107BA}" type="datetimeFigureOut">
              <a:rPr lang="en-US" smtClean="0"/>
              <a:t>7/1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5A509-114A-A744-AE76-97567B742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136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png"/><Relationship Id="rId3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png"/><Relationship Id="rId3" Type="http://schemas.openxmlformats.org/officeDocument/2006/relationships/image" Target="../media/image2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png"/><Relationship Id="rId3" Type="http://schemas.openxmlformats.org/officeDocument/2006/relationships/image" Target="../media/image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png"/><Relationship Id="rId3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5.png"/><Relationship Id="rId3" Type="http://schemas.openxmlformats.org/officeDocument/2006/relationships/image" Target="../media/image2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2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2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7.png"/><Relationship Id="rId3" Type="http://schemas.openxmlformats.org/officeDocument/2006/relationships/image" Target="../media/image2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Relationship Id="rId3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Relationship Id="rId3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png"/><Relationship Id="rId3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kex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29" b="65882"/>
          <a:stretch/>
        </p:blipFill>
        <p:spPr>
          <a:xfrm>
            <a:off x="2501684" y="1719196"/>
            <a:ext cx="4572000" cy="1981200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2501684" y="3818929"/>
            <a:ext cx="3425983" cy="1202216"/>
            <a:chOff x="2501684" y="3818929"/>
            <a:chExt cx="3425983" cy="1202216"/>
          </a:xfrm>
        </p:grpSpPr>
        <p:sp>
          <p:nvSpPr>
            <p:cNvPr id="7" name="TextBox 6"/>
            <p:cNvSpPr txBox="1"/>
            <p:nvPr/>
          </p:nvSpPr>
          <p:spPr>
            <a:xfrm>
              <a:off x="2501684" y="3818929"/>
              <a:ext cx="342598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Gene name: </a:t>
              </a:r>
              <a:r>
                <a:rPr lang="en-US" sz="1200" i="1" dirty="0" smtClean="0">
                  <a:latin typeface="Arial"/>
                  <a:cs typeface="Arial"/>
                </a:rPr>
                <a:t>KEX1</a:t>
              </a:r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b="1" i="1" dirty="0" smtClean="0">
                <a:latin typeface="Arial"/>
                <a:cs typeface="Arial"/>
              </a:endParaRPr>
            </a:p>
            <a:p>
              <a:r>
                <a:rPr lang="en-US" sz="1200" b="1" i="1" dirty="0" smtClean="0">
                  <a:latin typeface="Arial"/>
                  <a:cs typeface="Arial"/>
                </a:rPr>
                <a:t>Verticillium dahliae </a:t>
              </a:r>
              <a:r>
                <a:rPr lang="en-US" sz="1200" b="1" dirty="0" smtClean="0">
                  <a:latin typeface="Arial"/>
                  <a:cs typeface="Arial"/>
                </a:rPr>
                <a:t>Accession</a:t>
              </a:r>
              <a:r>
                <a:rPr lang="en-US" sz="1200" dirty="0" smtClean="0">
                  <a:latin typeface="Arial"/>
                  <a:cs typeface="Arial"/>
                </a:rPr>
                <a:t>: VDAG_00116  </a:t>
              </a:r>
              <a:endParaRPr lang="en-US" sz="1200" i="1" dirty="0" smtClean="0">
                <a:latin typeface="Arial"/>
                <a:cs typeface="Arial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700434" y="4624407"/>
              <a:ext cx="2949721" cy="396738"/>
              <a:chOff x="0" y="5389083"/>
              <a:chExt cx="2949721" cy="396738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1500" y="5389083"/>
                <a:ext cx="1574800" cy="169232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0" y="5539600"/>
                <a:ext cx="29497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Positive selection               Purifying selection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7416800" y="304800"/>
            <a:ext cx="12924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hort et al.</a:t>
            </a:r>
          </a:p>
          <a:p>
            <a:r>
              <a:rPr lang="en-US" sz="1200" dirty="0" smtClean="0">
                <a:latin typeface="Arial"/>
                <a:cs typeface="Arial"/>
              </a:rPr>
              <a:t>BMC Genomics</a:t>
            </a:r>
          </a:p>
          <a:p>
            <a:r>
              <a:rPr lang="en-US" sz="1200" dirty="0" smtClean="0">
                <a:latin typeface="Arial"/>
                <a:cs typeface="Arial"/>
              </a:rPr>
              <a:t>Additional File 4</a:t>
            </a:r>
          </a:p>
        </p:txBody>
      </p:sp>
    </p:spTree>
    <p:extLst>
      <p:ext uri="{BB962C8B-B14F-4D97-AF65-F5344CB8AC3E}">
        <p14:creationId xmlns:p14="http://schemas.microsoft.com/office/powerpoint/2010/main" val="41240226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CE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78" b="68982"/>
          <a:stretch/>
        </p:blipFill>
        <p:spPr>
          <a:xfrm>
            <a:off x="2912100" y="2477594"/>
            <a:ext cx="4572000" cy="1765300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2853050" y="4242894"/>
            <a:ext cx="3475818" cy="1202216"/>
            <a:chOff x="2501684" y="3818929"/>
            <a:chExt cx="3475818" cy="1202216"/>
          </a:xfrm>
        </p:grpSpPr>
        <p:sp>
          <p:nvSpPr>
            <p:cNvPr id="11" name="TextBox 10"/>
            <p:cNvSpPr txBox="1"/>
            <p:nvPr/>
          </p:nvSpPr>
          <p:spPr>
            <a:xfrm>
              <a:off x="2501684" y="3818929"/>
              <a:ext cx="347581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Gene name: </a:t>
              </a:r>
              <a:r>
                <a:rPr lang="en-US" sz="1200" i="1" dirty="0" smtClean="0">
                  <a:latin typeface="Arial"/>
                  <a:cs typeface="Arial"/>
                </a:rPr>
                <a:t>RCE1</a:t>
              </a:r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b="1" i="1" dirty="0" smtClean="0">
                <a:latin typeface="Arial"/>
                <a:cs typeface="Arial"/>
              </a:endParaRPr>
            </a:p>
            <a:p>
              <a:r>
                <a:rPr lang="en-US" sz="1200" b="1" i="1" dirty="0" smtClean="0">
                  <a:latin typeface="Arial"/>
                  <a:cs typeface="Arial"/>
                </a:rPr>
                <a:t>Verticillium dahliae </a:t>
              </a:r>
              <a:r>
                <a:rPr lang="en-US" sz="1200" b="1" dirty="0" smtClean="0">
                  <a:latin typeface="Arial"/>
                  <a:cs typeface="Arial"/>
                </a:rPr>
                <a:t>Accession:</a:t>
              </a:r>
              <a:r>
                <a:rPr lang="en-US" sz="1200" dirty="0" smtClean="0">
                  <a:latin typeface="Arial"/>
                  <a:cs typeface="Arial"/>
                </a:rPr>
                <a:t> VDAG_06292</a:t>
              </a:r>
              <a:endParaRPr lang="en-US" sz="1200" i="1" dirty="0" smtClean="0">
                <a:latin typeface="Arial"/>
                <a:cs typeface="Arial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2700434" y="4624407"/>
              <a:ext cx="2949721" cy="396738"/>
              <a:chOff x="0" y="5389083"/>
              <a:chExt cx="2949721" cy="396738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1500" y="5389083"/>
                <a:ext cx="1574800" cy="169232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0" y="5539600"/>
                <a:ext cx="29497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Positive selection               Purifying selection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88555" y="512780"/>
            <a:ext cx="4766889" cy="4932330"/>
            <a:chOff x="2853050" y="512780"/>
            <a:chExt cx="4766889" cy="4932330"/>
          </a:xfrm>
        </p:grpSpPr>
        <p:pic>
          <p:nvPicPr>
            <p:cNvPr id="2" name="Picture 1" descr="rec8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46" b="41110"/>
            <a:stretch/>
          </p:blipFill>
          <p:spPr>
            <a:xfrm>
              <a:off x="3047939" y="512780"/>
              <a:ext cx="4572000" cy="37338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853050" y="4242894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REC8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2664</a:t>
                </a:r>
                <a:r>
                  <a:rPr lang="en-US" sz="1200" b="1" dirty="0" smtClean="0">
                    <a:latin typeface="Arial"/>
                    <a:cs typeface="Arial"/>
                  </a:rPr>
                  <a:t> </a:t>
                </a:r>
                <a:endParaRPr lang="en-US" sz="1200" b="1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56475" y="127381"/>
            <a:ext cx="4631050" cy="5672616"/>
            <a:chOff x="2549757" y="127381"/>
            <a:chExt cx="4631050" cy="5672616"/>
          </a:xfrm>
        </p:grpSpPr>
        <p:pic>
          <p:nvPicPr>
            <p:cNvPr id="2" name="Picture 1" descr="RID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64" b="28951"/>
            <a:stretch/>
          </p:blipFill>
          <p:spPr>
            <a:xfrm>
              <a:off x="2608807" y="127381"/>
              <a:ext cx="4572000" cy="44704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549757" y="4597781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RID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1783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1651000"/>
            <a:ext cx="4572000" cy="2992916"/>
            <a:chOff x="2082800" y="1651000"/>
            <a:chExt cx="4572000" cy="2992916"/>
          </a:xfrm>
        </p:grpSpPr>
        <p:pic>
          <p:nvPicPr>
            <p:cNvPr id="2" name="Picture 1" descr="ski8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30" b="69258"/>
            <a:stretch/>
          </p:blipFill>
          <p:spPr>
            <a:xfrm>
              <a:off x="2082800" y="1651000"/>
              <a:ext cx="4572000" cy="17907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082800" y="3441700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SKI8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7486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1485900"/>
            <a:ext cx="4572000" cy="3362386"/>
            <a:chOff x="2006600" y="1485900"/>
            <a:chExt cx="4572000" cy="3362386"/>
          </a:xfrm>
        </p:grpSpPr>
        <p:pic>
          <p:nvPicPr>
            <p:cNvPr id="2" name="Picture 1" descr="spo11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55" b="62593"/>
            <a:stretch/>
          </p:blipFill>
          <p:spPr>
            <a:xfrm>
              <a:off x="2006600" y="1485900"/>
              <a:ext cx="4572000" cy="21844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006600" y="3646070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SPO11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9359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431800"/>
            <a:ext cx="4572000" cy="5596416"/>
            <a:chOff x="2501900" y="431800"/>
            <a:chExt cx="4572000" cy="5596416"/>
          </a:xfrm>
        </p:grpSpPr>
        <p:pic>
          <p:nvPicPr>
            <p:cNvPr id="2" name="Picture 1" descr="STE23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88" b="30937"/>
            <a:stretch/>
          </p:blipFill>
          <p:spPr>
            <a:xfrm>
              <a:off x="2501900" y="431800"/>
              <a:ext cx="4572000" cy="4394200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2501900" y="4826000"/>
              <a:ext cx="3475818" cy="1202216"/>
              <a:chOff x="2501684" y="3818929"/>
              <a:chExt cx="3475818" cy="1202216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STE23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5762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3" name="Group 12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5" name="TextBox 14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393699"/>
            <a:ext cx="4572000" cy="5634517"/>
            <a:chOff x="2832100" y="393699"/>
            <a:chExt cx="4572000" cy="5634517"/>
          </a:xfrm>
        </p:grpSpPr>
        <p:pic>
          <p:nvPicPr>
            <p:cNvPr id="2" name="Picture 1" descr="STE23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46" b="31862"/>
            <a:stretch/>
          </p:blipFill>
          <p:spPr>
            <a:xfrm>
              <a:off x="2832100" y="393699"/>
              <a:ext cx="4572000" cy="4292601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868327" y="4826000"/>
              <a:ext cx="3445896" cy="1202216"/>
              <a:chOff x="2501684" y="3818929"/>
              <a:chExt cx="3445896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45896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STE24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6443 </a:t>
                </a:r>
                <a:endParaRPr lang="en-US" sz="1200" i="1" dirty="0" smtClean="0">
                  <a:latin typeface="Arial"/>
                  <a:cs typeface="Arial"/>
                </a:endParaRPr>
              </a:p>
              <a:p>
                <a:r>
                  <a:rPr lang="en-US" sz="1200" dirty="0" smtClean="0">
                    <a:latin typeface="Arial"/>
                    <a:cs typeface="Arial"/>
                  </a:rPr>
                  <a:t>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2019300"/>
            <a:ext cx="4572000" cy="2091216"/>
            <a:chOff x="2273300" y="2019300"/>
            <a:chExt cx="4572000" cy="2091216"/>
          </a:xfrm>
        </p:grpSpPr>
        <p:pic>
          <p:nvPicPr>
            <p:cNvPr id="2" name="Picture 1" descr="V-SNARE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71" b="81666"/>
            <a:stretch/>
          </p:blipFill>
          <p:spPr>
            <a:xfrm>
              <a:off x="2273300" y="2019300"/>
              <a:ext cx="4572000" cy="8890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273300" y="2908300"/>
              <a:ext cx="3445896" cy="1202216"/>
              <a:chOff x="2501684" y="3818929"/>
              <a:chExt cx="3445896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45896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V-SNARE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6443 </a:t>
                </a:r>
                <a:endParaRPr lang="en-US" sz="1200" i="1" dirty="0" smtClean="0">
                  <a:latin typeface="Arial"/>
                  <a:cs typeface="Arial"/>
                </a:endParaRPr>
              </a:p>
              <a:p>
                <a:r>
                  <a:rPr lang="en-US" sz="1200" dirty="0" smtClean="0">
                    <a:latin typeface="Arial"/>
                    <a:cs typeface="Arial"/>
                  </a:rPr>
                  <a:t>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206500" y="1557865"/>
            <a:ext cx="6731000" cy="4581561"/>
            <a:chOff x="1296979" y="1557865"/>
            <a:chExt cx="6731000" cy="4581561"/>
          </a:xfrm>
        </p:grpSpPr>
        <p:pic>
          <p:nvPicPr>
            <p:cNvPr id="2" name="Picture 1" descr="STE6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81" r="26389" b="49029"/>
            <a:stretch/>
          </p:blipFill>
          <p:spPr>
            <a:xfrm>
              <a:off x="1296979" y="1557865"/>
              <a:ext cx="3365500" cy="3051089"/>
            </a:xfrm>
            <a:prstGeom prst="rect">
              <a:avLst/>
            </a:prstGeom>
          </p:spPr>
        </p:pic>
        <p:grpSp>
          <p:nvGrpSpPr>
            <p:cNvPr id="13" name="Group 12"/>
            <p:cNvGrpSpPr/>
            <p:nvPr/>
          </p:nvGrpSpPr>
          <p:grpSpPr>
            <a:xfrm>
              <a:off x="2939531" y="4937210"/>
              <a:ext cx="3445896" cy="1202216"/>
              <a:chOff x="2501684" y="3818929"/>
              <a:chExt cx="3445896" cy="1202216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2501684" y="3818929"/>
                <a:ext cx="3445896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 V-SNARE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 </a:t>
                </a:r>
                <a:r>
                  <a:rPr lang="en-US" sz="1200" dirty="0" smtClean="0">
                    <a:latin typeface="Arial"/>
                    <a:cs typeface="Arial"/>
                  </a:rPr>
                  <a:t>VDAG_06443 </a:t>
                </a:r>
                <a:endParaRPr lang="en-US" sz="1200" i="1" dirty="0" smtClean="0">
                  <a:latin typeface="Arial"/>
                  <a:cs typeface="Arial"/>
                </a:endParaRPr>
              </a:p>
              <a:p>
                <a:r>
                  <a:rPr lang="en-US" sz="1200" dirty="0" smtClean="0">
                    <a:latin typeface="Arial"/>
                    <a:cs typeface="Arial"/>
                  </a:rPr>
                  <a:t>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5" name="Group 14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7" name="TextBox 16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  <p:pic>
          <p:nvPicPr>
            <p:cNvPr id="18" name="Picture 17" descr="STE6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724" r="26389"/>
            <a:stretch/>
          </p:blipFill>
          <p:spPr>
            <a:xfrm>
              <a:off x="4662479" y="1557865"/>
              <a:ext cx="3365500" cy="337934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ei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5" b="65846"/>
          <a:stretch/>
        </p:blipFill>
        <p:spPr>
          <a:xfrm>
            <a:off x="2584823" y="1862666"/>
            <a:ext cx="4572000" cy="1981201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2584823" y="3776134"/>
            <a:ext cx="3437405" cy="1202216"/>
            <a:chOff x="2501684" y="3818929"/>
            <a:chExt cx="3437405" cy="1202216"/>
          </a:xfrm>
        </p:grpSpPr>
        <p:sp>
          <p:nvSpPr>
            <p:cNvPr id="12" name="TextBox 11"/>
            <p:cNvSpPr txBox="1"/>
            <p:nvPr/>
          </p:nvSpPr>
          <p:spPr>
            <a:xfrm>
              <a:off x="2501684" y="3818929"/>
              <a:ext cx="343740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Gene name: </a:t>
              </a:r>
              <a:r>
                <a:rPr lang="en-US" sz="1200" i="1" dirty="0" smtClean="0">
                  <a:latin typeface="Arial"/>
                  <a:cs typeface="Arial"/>
                </a:rPr>
                <a:t>MEI3</a:t>
              </a:r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b="1" i="1" dirty="0" smtClean="0">
                <a:latin typeface="Arial"/>
                <a:cs typeface="Arial"/>
              </a:endParaRPr>
            </a:p>
            <a:p>
              <a:r>
                <a:rPr lang="en-US" sz="1200" b="1" i="1" dirty="0" smtClean="0">
                  <a:latin typeface="Arial"/>
                  <a:cs typeface="Arial"/>
                </a:rPr>
                <a:t>Verticillium dahliae </a:t>
              </a:r>
              <a:r>
                <a:rPr lang="en-US" sz="1200" b="1" dirty="0" smtClean="0">
                  <a:latin typeface="Arial"/>
                  <a:cs typeface="Arial"/>
                </a:rPr>
                <a:t>Accession</a:t>
              </a:r>
              <a:r>
                <a:rPr lang="en-US" sz="1200" dirty="0" smtClean="0">
                  <a:latin typeface="Arial"/>
                  <a:cs typeface="Arial"/>
                </a:rPr>
                <a:t>: VDAG_08796  </a:t>
              </a:r>
              <a:endParaRPr lang="en-US" sz="1200" i="1" dirty="0" smtClean="0">
                <a:latin typeface="Arial"/>
                <a:cs typeface="Arial"/>
              </a:endParaRP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2700434" y="4624407"/>
              <a:ext cx="2949721" cy="396738"/>
              <a:chOff x="0" y="5389083"/>
              <a:chExt cx="2949721" cy="396738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1500" y="5389083"/>
                <a:ext cx="1574800" cy="169232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0" y="5539600"/>
                <a:ext cx="29497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Positive selection               Purifying selection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32169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sh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54" b="37715"/>
          <a:stretch/>
        </p:blipFill>
        <p:spPr>
          <a:xfrm>
            <a:off x="2692400" y="440266"/>
            <a:ext cx="4572000" cy="3945467"/>
          </a:xfrm>
          <a:prstGeom prst="rect">
            <a:avLst/>
          </a:prstGeom>
        </p:spPr>
      </p:pic>
      <p:grpSp>
        <p:nvGrpSpPr>
          <p:cNvPr id="15" name="Group 14"/>
          <p:cNvGrpSpPr/>
          <p:nvPr/>
        </p:nvGrpSpPr>
        <p:grpSpPr>
          <a:xfrm>
            <a:off x="2692400" y="4531685"/>
            <a:ext cx="3425983" cy="1202216"/>
            <a:chOff x="2501684" y="3818929"/>
            <a:chExt cx="3425983" cy="1202216"/>
          </a:xfrm>
        </p:grpSpPr>
        <p:sp>
          <p:nvSpPr>
            <p:cNvPr id="16" name="TextBox 15"/>
            <p:cNvSpPr txBox="1"/>
            <p:nvPr/>
          </p:nvSpPr>
          <p:spPr>
            <a:xfrm>
              <a:off x="2501684" y="3818929"/>
              <a:ext cx="342598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Gene name: </a:t>
              </a:r>
              <a:r>
                <a:rPr lang="en-US" sz="1200" i="1" dirty="0" smtClean="0">
                  <a:latin typeface="Arial"/>
                  <a:cs typeface="Arial"/>
                </a:rPr>
                <a:t>MSH4</a:t>
              </a:r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b="1" i="1" dirty="0" smtClean="0">
                <a:latin typeface="Arial"/>
                <a:cs typeface="Arial"/>
              </a:endParaRPr>
            </a:p>
            <a:p>
              <a:r>
                <a:rPr lang="en-US" sz="1200" b="1" i="1" dirty="0" smtClean="0">
                  <a:latin typeface="Arial"/>
                  <a:cs typeface="Arial"/>
                </a:rPr>
                <a:t>Verticillium dahliae </a:t>
              </a:r>
              <a:r>
                <a:rPr lang="en-US" sz="1200" b="1" dirty="0" smtClean="0">
                  <a:latin typeface="Arial"/>
                  <a:cs typeface="Arial"/>
                </a:rPr>
                <a:t>Accession:</a:t>
              </a:r>
              <a:r>
                <a:rPr lang="en-US" sz="1200" dirty="0" smtClean="0">
                  <a:latin typeface="Arial"/>
                  <a:cs typeface="Arial"/>
                </a:rPr>
                <a:t> VDAG_02856 </a:t>
              </a:r>
              <a:endParaRPr lang="en-US" sz="1200" i="1" dirty="0" smtClean="0">
                <a:latin typeface="Arial"/>
                <a:cs typeface="Arial"/>
              </a:endParaRP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2700434" y="4624407"/>
              <a:ext cx="2949721" cy="396738"/>
              <a:chOff x="0" y="5389083"/>
              <a:chExt cx="2949721" cy="396738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1500" y="5389083"/>
                <a:ext cx="1574800" cy="169232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0" y="5539600"/>
                <a:ext cx="29497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Positive selection               Purifying selection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546099"/>
            <a:ext cx="4572000" cy="5187802"/>
            <a:chOff x="2514600" y="546099"/>
            <a:chExt cx="4572000" cy="5187802"/>
          </a:xfrm>
        </p:grpSpPr>
        <p:pic>
          <p:nvPicPr>
            <p:cNvPr id="2" name="Picture 1" descr="msh5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15" b="35197"/>
            <a:stretch/>
          </p:blipFill>
          <p:spPr>
            <a:xfrm>
              <a:off x="2514600" y="546099"/>
              <a:ext cx="4572000" cy="4038601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2514600" y="4531685"/>
              <a:ext cx="3531481" cy="1202216"/>
              <a:chOff x="2501684" y="3818929"/>
              <a:chExt cx="3531481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531481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MSH5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</a:t>
                </a:r>
                <a:r>
                  <a:rPr lang="en-US" sz="1200" dirty="0" smtClean="0">
                    <a:latin typeface="Arial"/>
                    <a:cs typeface="Arial"/>
                  </a:rPr>
                  <a:t> VDAG_08845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121595"/>
            <a:ext cx="4572000" cy="6587016"/>
            <a:chOff x="3064934" y="121595"/>
            <a:chExt cx="4572000" cy="6587016"/>
          </a:xfrm>
        </p:grpSpPr>
        <p:pic>
          <p:nvPicPr>
            <p:cNvPr id="2" name="Picture 1" descr="mus-50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55" b="15926"/>
            <a:stretch/>
          </p:blipFill>
          <p:spPr>
            <a:xfrm>
              <a:off x="3064934" y="121595"/>
              <a:ext cx="4572000" cy="53848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3064934" y="5506395"/>
              <a:ext cx="3445896" cy="1202216"/>
              <a:chOff x="2501684" y="3818929"/>
              <a:chExt cx="3445896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45896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MUS50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</a:t>
                </a:r>
                <a:r>
                  <a:rPr lang="en-US" sz="1200" dirty="0" smtClean="0">
                    <a:latin typeface="Arial"/>
                    <a:cs typeface="Arial"/>
                  </a:rPr>
                  <a:t> VDAG_01559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965200"/>
            <a:ext cx="4572000" cy="4707416"/>
            <a:chOff x="3302000" y="965200"/>
            <a:chExt cx="4572000" cy="4707416"/>
          </a:xfrm>
        </p:grpSpPr>
        <p:pic>
          <p:nvPicPr>
            <p:cNvPr id="2" name="Picture 1" descr="mutL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29" b="44259"/>
            <a:stretch/>
          </p:blipFill>
          <p:spPr>
            <a:xfrm>
              <a:off x="3302000" y="965200"/>
              <a:ext cx="4572000" cy="35052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3302000" y="4470400"/>
              <a:ext cx="3425983" cy="1202216"/>
              <a:chOff x="2501684" y="3818929"/>
              <a:chExt cx="3425983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2598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MUTL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</a:t>
                </a:r>
                <a:r>
                  <a:rPr lang="en-US" sz="1200" dirty="0" smtClean="0">
                    <a:latin typeface="Arial"/>
                    <a:cs typeface="Arial"/>
                  </a:rPr>
                  <a:t> VDAG_01559 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1435100"/>
            <a:ext cx="4572000" cy="4237516"/>
            <a:chOff x="3302000" y="1435100"/>
            <a:chExt cx="4572000" cy="4237516"/>
          </a:xfrm>
        </p:grpSpPr>
        <p:pic>
          <p:nvPicPr>
            <p:cNvPr id="2" name="Picture 1" descr="rad-21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26" b="49815"/>
            <a:stretch/>
          </p:blipFill>
          <p:spPr>
            <a:xfrm>
              <a:off x="3302000" y="1435100"/>
              <a:ext cx="4572000" cy="30353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3302000" y="4470400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RAD21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</a:t>
                </a:r>
                <a:r>
                  <a:rPr lang="en-US" sz="1200" dirty="0" smtClean="0">
                    <a:latin typeface="Arial"/>
                    <a:cs typeface="Arial"/>
                  </a:rPr>
                  <a:t> VDAG_08702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86000" y="1003847"/>
            <a:ext cx="4572000" cy="4441263"/>
            <a:chOff x="3361050" y="1003847"/>
            <a:chExt cx="4572000" cy="4441263"/>
          </a:xfrm>
        </p:grpSpPr>
        <p:pic>
          <p:nvPicPr>
            <p:cNvPr id="2" name="Picture 1" descr="rad54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15" b="48704"/>
            <a:stretch/>
          </p:blipFill>
          <p:spPr>
            <a:xfrm>
              <a:off x="3361050" y="1003847"/>
              <a:ext cx="4572000" cy="318770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3361050" y="4242894"/>
              <a:ext cx="3475818" cy="1202216"/>
              <a:chOff x="2501684" y="3818929"/>
              <a:chExt cx="3475818" cy="1202216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501684" y="3818929"/>
                <a:ext cx="347581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e name: </a:t>
                </a:r>
                <a:r>
                  <a:rPr lang="en-US" sz="1200" i="1" dirty="0" smtClean="0">
                    <a:latin typeface="Arial"/>
                    <a:cs typeface="Arial"/>
                  </a:rPr>
                  <a:t>RAD54</a:t>
                </a:r>
                <a:endParaRPr lang="en-US" sz="1200" dirty="0" smtClean="0">
                  <a:latin typeface="Arial"/>
                  <a:cs typeface="Arial"/>
                </a:endParaRPr>
              </a:p>
              <a:p>
                <a:endParaRPr lang="en-US" sz="1200" b="1" i="1" dirty="0" smtClean="0">
                  <a:latin typeface="Arial"/>
                  <a:cs typeface="Arial"/>
                </a:endParaRPr>
              </a:p>
              <a:p>
                <a:r>
                  <a:rPr lang="en-US" sz="1200" b="1" i="1" dirty="0" smtClean="0">
                    <a:latin typeface="Arial"/>
                    <a:cs typeface="Arial"/>
                  </a:rPr>
                  <a:t>Verticillium dahliae </a:t>
                </a:r>
                <a:r>
                  <a:rPr lang="en-US" sz="1200" b="1" dirty="0" smtClean="0">
                    <a:latin typeface="Arial"/>
                    <a:cs typeface="Arial"/>
                  </a:rPr>
                  <a:t>Accession:</a:t>
                </a:r>
                <a:r>
                  <a:rPr lang="en-US" sz="1200" dirty="0" smtClean="0">
                    <a:latin typeface="Arial"/>
                    <a:cs typeface="Arial"/>
                  </a:rPr>
                  <a:t> VDAG_02310</a:t>
                </a:r>
                <a:endParaRPr lang="en-US" sz="1200" i="1" dirty="0" smtClean="0">
                  <a:latin typeface="Arial"/>
                  <a:cs typeface="Arial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2700434" y="4624407"/>
                <a:ext cx="2949721" cy="396738"/>
                <a:chOff x="0" y="5389083"/>
                <a:chExt cx="2949721" cy="396738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1500" y="5389083"/>
                  <a:ext cx="1574800" cy="169232"/>
                </a:xfrm>
                <a:prstGeom prst="rect">
                  <a:avLst/>
                </a:prstGeom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0" y="5539600"/>
                  <a:ext cx="29497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/>
                      <a:cs typeface="Arial"/>
                    </a:rPr>
                    <a:t>Positive selection               Purifying selection</a:t>
                  </a:r>
                  <a:endParaRPr lang="en-US" sz="1000" b="1" dirty="0">
                    <a:latin typeface="Arial"/>
                    <a:cs typeface="Arial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AM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4" b="59815"/>
          <a:stretch/>
        </p:blipFill>
        <p:spPr>
          <a:xfrm>
            <a:off x="2929405" y="1638300"/>
            <a:ext cx="4572000" cy="2476500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2853050" y="4242894"/>
            <a:ext cx="3475818" cy="1202216"/>
            <a:chOff x="2501684" y="3818929"/>
            <a:chExt cx="3475818" cy="1202216"/>
          </a:xfrm>
        </p:grpSpPr>
        <p:sp>
          <p:nvSpPr>
            <p:cNvPr id="11" name="TextBox 10"/>
            <p:cNvSpPr txBox="1"/>
            <p:nvPr/>
          </p:nvSpPr>
          <p:spPr>
            <a:xfrm>
              <a:off x="2501684" y="3818929"/>
              <a:ext cx="347581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Gene name: </a:t>
              </a:r>
              <a:r>
                <a:rPr lang="en-US" sz="1200" i="1" dirty="0" smtClean="0">
                  <a:latin typeface="Arial"/>
                  <a:cs typeface="Arial"/>
                </a:rPr>
                <a:t>RAM1</a:t>
              </a:r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b="1" i="1" dirty="0" smtClean="0">
                <a:latin typeface="Arial"/>
                <a:cs typeface="Arial"/>
              </a:endParaRPr>
            </a:p>
            <a:p>
              <a:r>
                <a:rPr lang="en-US" sz="1200" b="1" i="1" dirty="0" smtClean="0">
                  <a:latin typeface="Arial"/>
                  <a:cs typeface="Arial"/>
                </a:rPr>
                <a:t>Verticillium dahliae </a:t>
              </a:r>
              <a:r>
                <a:rPr lang="en-US" sz="1200" b="1" dirty="0" smtClean="0">
                  <a:latin typeface="Arial"/>
                  <a:cs typeface="Arial"/>
                </a:rPr>
                <a:t>Accession:</a:t>
              </a:r>
              <a:r>
                <a:rPr lang="en-US" sz="1200" dirty="0" smtClean="0">
                  <a:latin typeface="Arial"/>
                  <a:cs typeface="Arial"/>
                </a:rPr>
                <a:t> VDAG_05598</a:t>
              </a:r>
              <a:endParaRPr lang="en-US" sz="1200" i="1" dirty="0" smtClean="0">
                <a:latin typeface="Arial"/>
                <a:cs typeface="Arial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2700434" y="4624407"/>
              <a:ext cx="2949721" cy="396738"/>
              <a:chOff x="0" y="5389083"/>
              <a:chExt cx="2949721" cy="396738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1500" y="5389083"/>
                <a:ext cx="1574800" cy="169232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0" y="5539600"/>
                <a:ext cx="29497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Positive selection               Purifying selection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838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</TotalTime>
  <Words>250</Words>
  <Application>Microsoft Macintosh PowerPoint</Application>
  <PresentationFormat>On-screen Show (4:3)</PresentationFormat>
  <Paragraphs>78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>UCD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ubbarao's Lab Plant Pathology</dc:creator>
  <cp:keywords/>
  <dc:description/>
  <cp:lastModifiedBy>Subbarao's Lab Plant Pathology</cp:lastModifiedBy>
  <cp:revision>20</cp:revision>
  <dcterms:created xsi:type="dcterms:W3CDTF">2014-07-02T21:22:05Z</dcterms:created>
  <dcterms:modified xsi:type="dcterms:W3CDTF">2014-07-14T22:51:54Z</dcterms:modified>
  <cp:category/>
</cp:coreProperties>
</file>